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144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514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154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069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964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726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345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720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958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504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049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441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1C488D-A8C8-4124-B986-C070BC8DFA46}" type="datetimeFigureOut">
              <a:rPr lang="en-US" smtClean="0"/>
              <a:t>11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983D3-282A-49AE-B3C2-05C20B8C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131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1.doc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/>
          <p:cNvSpPr txBox="1"/>
          <p:nvPr/>
        </p:nvSpPr>
        <p:spPr>
          <a:xfrm>
            <a:off x="395536" y="2606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1</a:t>
            </a:r>
            <a:endParaRPr lang="en-GB" dirty="0"/>
          </a:p>
        </p:txBody>
      </p:sp>
      <p:pic>
        <p:nvPicPr>
          <p:cNvPr id="39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3795" y="236886"/>
            <a:ext cx="6360466" cy="6360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81255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3568" y="908720"/>
            <a:ext cx="7757957" cy="558457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5536" y="260648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291280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5536" y="260648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3</a:t>
            </a:r>
            <a:endParaRPr lang="en-GB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5656" y="836712"/>
            <a:ext cx="6988326" cy="5589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39443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7544" y="2132856"/>
            <a:ext cx="9720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able S1</a:t>
            </a:r>
            <a:endParaRPr lang="en-GB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6400947"/>
              </p:ext>
            </p:extLst>
          </p:nvPr>
        </p:nvGraphicFramePr>
        <p:xfrm>
          <a:off x="1907704" y="360178"/>
          <a:ext cx="5112567" cy="64063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Document" r:id="rId3" imgW="5816600" imgH="7289800" progId="Word.Document.12">
                  <p:embed/>
                </p:oleObj>
              </mc:Choice>
              <mc:Fallback>
                <p:oleObj name="Document" r:id="rId3" imgW="5816600" imgH="72898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07704" y="360178"/>
                        <a:ext cx="5112567" cy="64063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455492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8455965"/>
              </p:ext>
            </p:extLst>
          </p:nvPr>
        </p:nvGraphicFramePr>
        <p:xfrm>
          <a:off x="457199" y="1600203"/>
          <a:ext cx="8382000" cy="334825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311095"/>
                <a:gridCol w="2023635"/>
                <a:gridCol w="2023635"/>
                <a:gridCol w="2023635"/>
              </a:tblGrid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Primer name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rimer sequence</a:t>
                      </a:r>
                      <a:endParaRPr lang="en-US" sz="140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rimer quantity to order</a:t>
                      </a:r>
                      <a:endParaRPr lang="en-US" sz="140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Primer formulation</a:t>
                      </a:r>
                      <a:endParaRPr lang="en-US" sz="140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Pf1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TATATATAT*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50 nmol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TD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Pf2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ATATATATAT*T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50 nmol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TD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f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ATATATATA*A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50 nmol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TD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f4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AATATATA*T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50 nmol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TD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f5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ATATATATT*T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50 nmol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TD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f6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ATTATTATTA*T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50 </a:t>
                      </a:r>
                      <a:r>
                        <a:rPr lang="en-US" sz="1400" dirty="0" err="1">
                          <a:effectLst/>
                        </a:rPr>
                        <a:t>nmol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TD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f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AATAATAAT*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50 </a:t>
                      </a:r>
                      <a:r>
                        <a:rPr lang="en-US" sz="1400" dirty="0" err="1">
                          <a:effectLst/>
                        </a:rPr>
                        <a:t>nmol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TD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f8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AAAAAAAAAA*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50 </a:t>
                      </a:r>
                      <a:r>
                        <a:rPr lang="en-US" sz="1400" dirty="0" err="1">
                          <a:effectLst/>
                        </a:rPr>
                        <a:t>nmol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TD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24817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f9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ATAATAATA*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50 </a:t>
                      </a:r>
                      <a:r>
                        <a:rPr lang="en-US" sz="1400" dirty="0" err="1">
                          <a:effectLst/>
                        </a:rPr>
                        <a:t>nmol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TD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48551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f10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ATTATATA*T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50 </a:t>
                      </a:r>
                      <a:r>
                        <a:rPr lang="en-US" sz="1400" dirty="0" err="1">
                          <a:effectLst/>
                        </a:rPr>
                        <a:t>nmol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TD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381000">
                <a:tc gridSpan="4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b="0" dirty="0">
                          <a:effectLst/>
                        </a:rPr>
                        <a:t>* </a:t>
                      </a:r>
                      <a:r>
                        <a:rPr lang="en-US" sz="1600" b="0" dirty="0" err="1">
                          <a:effectLst/>
                        </a:rPr>
                        <a:t>phosphorothioate</a:t>
                      </a:r>
                      <a:r>
                        <a:rPr lang="en-US" sz="1600" b="0" dirty="0">
                          <a:effectLst/>
                        </a:rPr>
                        <a:t> bond.</a:t>
                      </a:r>
                      <a:endParaRPr lang="en-US" sz="16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57200" y="685800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able 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9010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74</Words>
  <Application>Microsoft Office PowerPoint</Application>
  <PresentationFormat>On-screen Show (4:3)</PresentationFormat>
  <Paragraphs>50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Times New Roman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yola, Samuel (ILRI)</dc:creator>
  <cp:lastModifiedBy>Oyola, Samuel (ILRI)</cp:lastModifiedBy>
  <cp:revision>14</cp:revision>
  <dcterms:created xsi:type="dcterms:W3CDTF">2016-07-27T07:21:52Z</dcterms:created>
  <dcterms:modified xsi:type="dcterms:W3CDTF">2016-11-11T12:36:07Z</dcterms:modified>
</cp:coreProperties>
</file>